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9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media/image1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972800" cy="10972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F470F-CB3E-4288-8A99-E245962E21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987768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7560" y="6342120"/>
            <a:ext cx="987768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E9EA8-08E3-4558-97B7-18BCC7D2E6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6091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7560" y="63421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609160" y="63421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94612-EBEB-4CB4-9B08-FE19FE505E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87280" y="25603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227000" y="25603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7560" y="63421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87280" y="63421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227000" y="6342120"/>
            <a:ext cx="31802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640BD-68C7-4BD3-B227-779C6DD889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7560" y="2560320"/>
            <a:ext cx="9877680" cy="7240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51"/>
              </a:spcBef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45B05-A116-40B2-92F3-4274362281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987768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045E3-4C64-4113-A85E-156B1C1A34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482004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609160" y="2560320"/>
            <a:ext cx="482004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B700B-85E5-41DA-9AFA-0813EED545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32D4F-CF2C-411F-A8EE-D910F8CC8A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7560" y="439560"/>
            <a:ext cx="9877680" cy="8478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51"/>
              </a:spcBef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DE210D-EADC-4193-ADC8-94CE20403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609160" y="2560320"/>
            <a:ext cx="482004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7560" y="63421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E0D43-63CD-40EC-BF76-1B71EF9DE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482004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6091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609160" y="63421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1ED09-BBE3-4252-8758-3C1BFA48CC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75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609160" y="2560320"/>
            <a:ext cx="482004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7560" y="6342120"/>
            <a:ext cx="9877680" cy="34534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3F47C-1A13-41BD-B99F-EBB1F4434B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7560" y="439560"/>
            <a:ext cx="9877680" cy="182880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ctr">
            <a:noAutofit/>
          </a:bodyPr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7560" y="2560320"/>
            <a:ext cx="9877680" cy="724068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rmAutofit/>
          </a:bodyPr>
          <a:p>
            <a:pPr marL="490680" indent="-490680">
              <a:spcBef>
                <a:spcPts val="1151"/>
              </a:spcBef>
              <a:buClr>
                <a:srgbClr val="000000"/>
              </a:buClr>
              <a:buFont typeface="Arial"/>
              <a:buChar char="•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1" marL="1062000" indent="-407880">
              <a:spcBef>
                <a:spcPts val="1151"/>
              </a:spcBef>
              <a:buClr>
                <a:srgbClr val="000000"/>
              </a:buClr>
              <a:buFont typeface="Arial"/>
              <a:buChar char="–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2" marL="1633680" indent="-327240">
              <a:spcBef>
                <a:spcPts val="1151"/>
              </a:spcBef>
              <a:buClr>
                <a:srgbClr val="000000"/>
              </a:buClr>
              <a:buFont typeface="Arial"/>
              <a:buChar char="•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3" marL="2286000" indent="-326880">
              <a:spcBef>
                <a:spcPts val="1151"/>
              </a:spcBef>
              <a:buClr>
                <a:srgbClr val="000000"/>
              </a:buClr>
              <a:buFont typeface="Arial"/>
              <a:buChar char="–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4" marL="2940120" indent="-32868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5" marL="2940120" indent="-32868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  <a:p>
            <a:pPr lvl="6" marL="2940120" indent="-32868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7560" y="9991800"/>
            <a:ext cx="2562480" cy="76176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Autofit/>
          </a:bodyPr>
          <a:lstStyle>
            <a:lvl1pPr indent="0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747960" y="9991800"/>
            <a:ext cx="3476880" cy="76176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Autofit/>
          </a:bodyPr>
          <a:lstStyle>
            <a:lvl1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862760" y="9991800"/>
            <a:ext cx="2562480" cy="761760"/>
          </a:xfrm>
          <a:prstGeom prst="rect">
            <a:avLst/>
          </a:prstGeom>
          <a:noFill/>
          <a:ln w="0">
            <a:noFill/>
          </a:ln>
        </p:spPr>
        <p:txBody>
          <a:bodyPr lIns="130680" rIns="130680" tIns="65160" bIns="65160" anchor="t">
            <a:noAutofit/>
          </a:bodyPr>
          <a:lstStyle>
            <a:lvl1pPr indent="0" algn="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  <a:defRPr b="0" lang="en-US" sz="2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306440"/>
                <a:tab algn="l" pos="2612880"/>
                <a:tab algn="l" pos="3919680"/>
                <a:tab algn="l" pos="5226120"/>
                <a:tab algn="l" pos="6532560"/>
                <a:tab algn="l" pos="7839000"/>
                <a:tab algn="l" pos="9145440"/>
                <a:tab algn="l" pos="10452240"/>
              </a:tabLst>
            </a:pPr>
            <a:fld id="{364BE228-E5DB-4F30-82CC-F270AA918685}" type="slidenum">
              <a:rPr b="0" lang="en-US" sz="2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330120" y="279360"/>
            <a:ext cx="2514600" cy="2539440"/>
            <a:chOff x="330120" y="279360"/>
            <a:chExt cx="2514600" cy="2539440"/>
          </a:xfrm>
        </p:grpSpPr>
        <p:pic>
          <p:nvPicPr>
            <p:cNvPr id="42" name="Picture 2" descr="G:\22-05-2012\G1 M.jpg"/>
            <p:cNvPicPr/>
            <p:nvPr/>
          </p:nvPicPr>
          <p:blipFill>
            <a:blip r:embed="rId1"/>
            <a:stretch/>
          </p:blipFill>
          <p:spPr>
            <a:xfrm>
              <a:off x="330120" y="27936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2"/>
            <p:cNvSpPr/>
            <p:nvPr/>
          </p:nvSpPr>
          <p:spPr>
            <a:xfrm>
              <a:off x="906120" y="251172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oup 3"/>
          <p:cNvGrpSpPr/>
          <p:nvPr/>
        </p:nvGrpSpPr>
        <p:grpSpPr>
          <a:xfrm>
            <a:off x="316080" y="8229600"/>
            <a:ext cx="2516040" cy="2520360"/>
            <a:chOff x="316080" y="8229600"/>
            <a:chExt cx="2516040" cy="2520360"/>
          </a:xfrm>
        </p:grpSpPr>
        <p:pic>
          <p:nvPicPr>
            <p:cNvPr id="45" name="Picture 3" descr="G:\22-05-2012\G5 M.jpg"/>
            <p:cNvPicPr/>
            <p:nvPr/>
          </p:nvPicPr>
          <p:blipFill>
            <a:blip r:embed="rId2"/>
            <a:stretch/>
          </p:blipFill>
          <p:spPr>
            <a:xfrm>
              <a:off x="316080" y="8229600"/>
              <a:ext cx="251604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5"/>
            <p:cNvSpPr/>
            <p:nvPr/>
          </p:nvSpPr>
          <p:spPr>
            <a:xfrm>
              <a:off x="963720" y="10442880"/>
              <a:ext cx="15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4"/>
          <p:cNvGrpSpPr/>
          <p:nvPr/>
        </p:nvGrpSpPr>
        <p:grpSpPr>
          <a:xfrm>
            <a:off x="5511960" y="277920"/>
            <a:ext cx="2514600" cy="2467800"/>
            <a:chOff x="5511960" y="277920"/>
            <a:chExt cx="2514600" cy="2467800"/>
          </a:xfrm>
        </p:grpSpPr>
        <p:pic>
          <p:nvPicPr>
            <p:cNvPr id="48" name="Picture 4" descr="G:\22-05-2012\G7 M.jpg"/>
            <p:cNvPicPr/>
            <p:nvPr/>
          </p:nvPicPr>
          <p:blipFill>
            <a:blip r:embed="rId3"/>
            <a:stretch/>
          </p:blipFill>
          <p:spPr>
            <a:xfrm>
              <a:off x="5511960" y="27792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8"/>
            <p:cNvSpPr/>
            <p:nvPr/>
          </p:nvSpPr>
          <p:spPr>
            <a:xfrm>
              <a:off x="6087960" y="243864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6"/>
          <p:cNvGrpSpPr/>
          <p:nvPr/>
        </p:nvGrpSpPr>
        <p:grpSpPr>
          <a:xfrm>
            <a:off x="304920" y="2895480"/>
            <a:ext cx="2514600" cy="2540880"/>
            <a:chOff x="304920" y="2895480"/>
            <a:chExt cx="2514600" cy="2540880"/>
          </a:xfrm>
        </p:grpSpPr>
        <p:pic>
          <p:nvPicPr>
            <p:cNvPr id="51" name="Picture 5" descr="G:\22-05-2012\G9 M.jpg"/>
            <p:cNvPicPr/>
            <p:nvPr/>
          </p:nvPicPr>
          <p:blipFill>
            <a:blip r:embed="rId4"/>
            <a:stretch/>
          </p:blipFill>
          <p:spPr>
            <a:xfrm>
              <a:off x="304920" y="2895480"/>
              <a:ext cx="2514600" cy="216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11"/>
            <p:cNvSpPr/>
            <p:nvPr/>
          </p:nvSpPr>
          <p:spPr>
            <a:xfrm>
              <a:off x="808200" y="512928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Group 7"/>
          <p:cNvGrpSpPr/>
          <p:nvPr/>
        </p:nvGrpSpPr>
        <p:grpSpPr>
          <a:xfrm>
            <a:off x="2895480" y="2895480"/>
            <a:ext cx="2514600" cy="2540880"/>
            <a:chOff x="2895480" y="2895480"/>
            <a:chExt cx="2514600" cy="2540880"/>
          </a:xfrm>
        </p:grpSpPr>
        <p:pic>
          <p:nvPicPr>
            <p:cNvPr id="54" name="Picture 6" descr="G:\22-05-2012\G10 M.jpg"/>
            <p:cNvPicPr/>
            <p:nvPr/>
          </p:nvPicPr>
          <p:blipFill>
            <a:blip r:embed="rId5"/>
            <a:stretch/>
          </p:blipFill>
          <p:spPr>
            <a:xfrm>
              <a:off x="2895480" y="2895480"/>
              <a:ext cx="2514600" cy="216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Box 13"/>
            <p:cNvSpPr/>
            <p:nvPr/>
          </p:nvSpPr>
          <p:spPr>
            <a:xfrm>
              <a:off x="3398760" y="512928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j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Group 9"/>
          <p:cNvGrpSpPr/>
          <p:nvPr/>
        </p:nvGrpSpPr>
        <p:grpSpPr>
          <a:xfrm>
            <a:off x="5473800" y="2882880"/>
            <a:ext cx="2514600" cy="2539440"/>
            <a:chOff x="5473800" y="2882880"/>
            <a:chExt cx="2514600" cy="2539440"/>
          </a:xfrm>
        </p:grpSpPr>
        <p:pic>
          <p:nvPicPr>
            <p:cNvPr id="57" name="Picture 7" descr="G:\22-05-2012\G11 M.jpg"/>
            <p:cNvPicPr/>
            <p:nvPr/>
          </p:nvPicPr>
          <p:blipFill>
            <a:blip r:embed="rId6"/>
            <a:stretch/>
          </p:blipFill>
          <p:spPr>
            <a:xfrm>
              <a:off x="5473800" y="288288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17"/>
            <p:cNvSpPr/>
            <p:nvPr/>
          </p:nvSpPr>
          <p:spPr>
            <a:xfrm>
              <a:off x="6121440" y="511524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 1"/>
          <p:cNvGrpSpPr/>
          <p:nvPr/>
        </p:nvGrpSpPr>
        <p:grpSpPr>
          <a:xfrm>
            <a:off x="8077320" y="2886120"/>
            <a:ext cx="2514600" cy="2539440"/>
            <a:chOff x="8077320" y="2886120"/>
            <a:chExt cx="2514600" cy="2539440"/>
          </a:xfrm>
        </p:grpSpPr>
        <p:pic>
          <p:nvPicPr>
            <p:cNvPr id="60" name="Picture 2" descr="G:\22-05-2012\G12 M.jpg"/>
            <p:cNvPicPr/>
            <p:nvPr/>
          </p:nvPicPr>
          <p:blipFill>
            <a:blip r:embed="rId7"/>
            <a:stretch/>
          </p:blipFill>
          <p:spPr>
            <a:xfrm>
              <a:off x="8077320" y="288612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TextBox 2"/>
            <p:cNvSpPr/>
            <p:nvPr/>
          </p:nvSpPr>
          <p:spPr>
            <a:xfrm>
              <a:off x="8508960" y="511848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Group 3"/>
          <p:cNvGrpSpPr/>
          <p:nvPr/>
        </p:nvGrpSpPr>
        <p:grpSpPr>
          <a:xfrm>
            <a:off x="317520" y="5546880"/>
            <a:ext cx="2514600" cy="2539080"/>
            <a:chOff x="317520" y="5546880"/>
            <a:chExt cx="2514600" cy="2539080"/>
          </a:xfrm>
        </p:grpSpPr>
        <p:pic>
          <p:nvPicPr>
            <p:cNvPr id="63" name="Picture 3" descr="G:\22-05-2012\G13 M.jpg"/>
            <p:cNvPicPr/>
            <p:nvPr/>
          </p:nvPicPr>
          <p:blipFill>
            <a:blip r:embed="rId8"/>
            <a:stretch/>
          </p:blipFill>
          <p:spPr>
            <a:xfrm>
              <a:off x="317520" y="5546880"/>
              <a:ext cx="2514600" cy="216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TextBox 4"/>
            <p:cNvSpPr/>
            <p:nvPr/>
          </p:nvSpPr>
          <p:spPr>
            <a:xfrm>
              <a:off x="893520" y="777888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Group 5"/>
          <p:cNvGrpSpPr/>
          <p:nvPr/>
        </p:nvGrpSpPr>
        <p:grpSpPr>
          <a:xfrm>
            <a:off x="8102520" y="279360"/>
            <a:ext cx="2516400" cy="2539440"/>
            <a:chOff x="8102520" y="279360"/>
            <a:chExt cx="2516400" cy="2539440"/>
          </a:xfrm>
        </p:grpSpPr>
        <p:pic>
          <p:nvPicPr>
            <p:cNvPr id="66" name="Picture 5" descr="G:\22-05-2012\G8 M.jpg"/>
            <p:cNvPicPr/>
            <p:nvPr/>
          </p:nvPicPr>
          <p:blipFill>
            <a:blip r:embed="rId9"/>
            <a:stretch/>
          </p:blipFill>
          <p:spPr>
            <a:xfrm>
              <a:off x="8102520" y="279360"/>
              <a:ext cx="25164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TextBox 10"/>
            <p:cNvSpPr/>
            <p:nvPr/>
          </p:nvSpPr>
          <p:spPr>
            <a:xfrm>
              <a:off x="8607240" y="251172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Group 2"/>
          <p:cNvGrpSpPr/>
          <p:nvPr/>
        </p:nvGrpSpPr>
        <p:grpSpPr>
          <a:xfrm>
            <a:off x="5486400" y="5537160"/>
            <a:ext cx="2514600" cy="2539440"/>
            <a:chOff x="5486400" y="5537160"/>
            <a:chExt cx="2514600" cy="2539440"/>
          </a:xfrm>
        </p:grpSpPr>
        <p:pic>
          <p:nvPicPr>
            <p:cNvPr id="69" name="Picture 2" descr="G:\24-05-2012\G16 M.jpg"/>
            <p:cNvPicPr/>
            <p:nvPr/>
          </p:nvPicPr>
          <p:blipFill>
            <a:blip r:embed="rId10"/>
            <a:stretch/>
          </p:blipFill>
          <p:spPr>
            <a:xfrm>
              <a:off x="5486400" y="553716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TextBox 1"/>
            <p:cNvSpPr/>
            <p:nvPr/>
          </p:nvSpPr>
          <p:spPr>
            <a:xfrm>
              <a:off x="5918040" y="776952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1" name="Group 3"/>
          <p:cNvGrpSpPr/>
          <p:nvPr/>
        </p:nvGrpSpPr>
        <p:grpSpPr>
          <a:xfrm>
            <a:off x="8064360" y="5530680"/>
            <a:ext cx="2514600" cy="2539440"/>
            <a:chOff x="8064360" y="5530680"/>
            <a:chExt cx="2514600" cy="2539440"/>
          </a:xfrm>
        </p:grpSpPr>
        <p:pic>
          <p:nvPicPr>
            <p:cNvPr id="72" name="Picture 3" descr="G:\24-05-2012\G17 M.jpg"/>
            <p:cNvPicPr/>
            <p:nvPr/>
          </p:nvPicPr>
          <p:blipFill>
            <a:blip r:embed="rId11"/>
            <a:stretch/>
          </p:blipFill>
          <p:spPr>
            <a:xfrm>
              <a:off x="8064360" y="553068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TextBox 5"/>
            <p:cNvSpPr/>
            <p:nvPr/>
          </p:nvSpPr>
          <p:spPr>
            <a:xfrm>
              <a:off x="8640360" y="776304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q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Group 6"/>
          <p:cNvGrpSpPr/>
          <p:nvPr/>
        </p:nvGrpSpPr>
        <p:grpSpPr>
          <a:xfrm>
            <a:off x="2921040" y="282600"/>
            <a:ext cx="2516040" cy="2539440"/>
            <a:chOff x="2921040" y="282600"/>
            <a:chExt cx="2516040" cy="2539440"/>
          </a:xfrm>
        </p:grpSpPr>
        <p:pic>
          <p:nvPicPr>
            <p:cNvPr id="75" name="Picture 4" descr="G:\24-05-2012\G19 M.jpg"/>
            <p:cNvPicPr/>
            <p:nvPr/>
          </p:nvPicPr>
          <p:blipFill>
            <a:blip r:embed="rId12"/>
            <a:stretch/>
          </p:blipFill>
          <p:spPr>
            <a:xfrm>
              <a:off x="2921040" y="282600"/>
              <a:ext cx="251604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TextBox 8"/>
            <p:cNvSpPr/>
            <p:nvPr/>
          </p:nvSpPr>
          <p:spPr>
            <a:xfrm>
              <a:off x="3641760" y="251496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4"/>
          <p:cNvGrpSpPr/>
          <p:nvPr/>
        </p:nvGrpSpPr>
        <p:grpSpPr>
          <a:xfrm>
            <a:off x="2895480" y="8232840"/>
            <a:ext cx="2514600" cy="2539440"/>
            <a:chOff x="2895480" y="8232840"/>
            <a:chExt cx="2514600" cy="2539440"/>
          </a:xfrm>
        </p:grpSpPr>
        <p:pic>
          <p:nvPicPr>
            <p:cNvPr id="78" name="Picture 5" descr="G:\24-05-2012\G20 M.jpg"/>
            <p:cNvPicPr/>
            <p:nvPr/>
          </p:nvPicPr>
          <p:blipFill>
            <a:blip r:embed="rId13"/>
            <a:stretch/>
          </p:blipFill>
          <p:spPr>
            <a:xfrm>
              <a:off x="2895480" y="8232840"/>
              <a:ext cx="2514600" cy="216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10"/>
            <p:cNvSpPr/>
            <p:nvPr/>
          </p:nvSpPr>
          <p:spPr>
            <a:xfrm>
              <a:off x="3543120" y="1046520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"/>
          <p:cNvGrpSpPr/>
          <p:nvPr/>
        </p:nvGrpSpPr>
        <p:grpSpPr>
          <a:xfrm>
            <a:off x="2908440" y="5541840"/>
            <a:ext cx="2514600" cy="2537640"/>
            <a:chOff x="2908440" y="5541840"/>
            <a:chExt cx="2514600" cy="2537640"/>
          </a:xfrm>
        </p:grpSpPr>
        <p:pic>
          <p:nvPicPr>
            <p:cNvPr id="81" name="Picture 4" descr="G:\22-05-2012\G15 M.jpg"/>
            <p:cNvPicPr/>
            <p:nvPr/>
          </p:nvPicPr>
          <p:blipFill>
            <a:blip r:embed="rId14"/>
            <a:stretch/>
          </p:blipFill>
          <p:spPr>
            <a:xfrm>
              <a:off x="2908440" y="5541840"/>
              <a:ext cx="251460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Box 7"/>
            <p:cNvSpPr/>
            <p:nvPr/>
          </p:nvSpPr>
          <p:spPr>
            <a:xfrm>
              <a:off x="3511440" y="7772400"/>
              <a:ext cx="158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BraA.GRF14.o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9:46:00Z</dcterms:created>
  <dc:creator>NIPGR</dc:creator>
  <dc:description/>
  <dc:language>en-US</dc:language>
  <cp:lastModifiedBy>NIPGR</cp:lastModifiedBy>
  <dcterms:modified xsi:type="dcterms:W3CDTF">2015-07-14T08:07:38Z</dcterms:modified>
  <cp:revision>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3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3.PPT</vt:lpwstr>
  </property>
</Properties>
</file>